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48991C-3386-4761-B1BE-61703F43D4A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sldImg"/>
          </p:nvPr>
        </p:nvSpPr>
        <p:spPr>
          <a:xfrm>
            <a:off x="1143000" y="695160"/>
            <a:ext cx="4567320" cy="3426120"/>
          </a:xfrm>
          <a:prstGeom prst="rect">
            <a:avLst/>
          </a:prstGeom>
          <a:ln w="0">
            <a:noFill/>
          </a:ln>
        </p:spPr>
      </p:sp>
      <p:sp>
        <p:nvSpPr>
          <p:cNvPr id="7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392040"/>
                <a:tab algn="l" pos="784080"/>
                <a:tab algn="l" pos="1176480"/>
                <a:tab algn="l" pos="1568520"/>
                <a:tab algn="l" pos="1960560"/>
                <a:tab algn="l" pos="2352600"/>
                <a:tab algn="l" pos="2744640"/>
                <a:tab algn="l" pos="3137040"/>
                <a:tab algn="l" pos="3529080"/>
                <a:tab algn="l" pos="3921120"/>
                <a:tab algn="l" pos="4313160"/>
                <a:tab algn="l" pos="4705200"/>
                <a:tab algn="l" pos="5097600"/>
                <a:tab algn="l" pos="5489640"/>
                <a:tab algn="l" pos="5881680"/>
                <a:tab algn="l" pos="6273720"/>
                <a:tab algn="l" pos="6665760"/>
                <a:tab algn="l" pos="7058160"/>
                <a:tab algn="l" pos="7450200"/>
                <a:tab algn="l" pos="7842240"/>
              </a:tabLst>
            </a:pPr>
            <a:fld id="{997B1356-3446-45AB-B992-6FD59EC4E2C3}" type="slidenum">
              <a:rPr b="0" lang="en-I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sldImg"/>
          </p:nvPr>
        </p:nvSpPr>
        <p:spPr>
          <a:xfrm>
            <a:off x="1143000" y="695160"/>
            <a:ext cx="4567320" cy="3426120"/>
          </a:xfrm>
          <a:prstGeom prst="rect">
            <a:avLst/>
          </a:prstGeom>
          <a:ln w="0">
            <a:noFill/>
          </a:ln>
        </p:spPr>
      </p:sp>
      <p:sp>
        <p:nvSpPr>
          <p:cNvPr id="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392040"/>
                <a:tab algn="l" pos="784080"/>
                <a:tab algn="l" pos="1176480"/>
                <a:tab algn="l" pos="1568520"/>
                <a:tab algn="l" pos="1960560"/>
                <a:tab algn="l" pos="2352600"/>
                <a:tab algn="l" pos="2744640"/>
                <a:tab algn="l" pos="3137040"/>
                <a:tab algn="l" pos="3529080"/>
                <a:tab algn="l" pos="3921120"/>
                <a:tab algn="l" pos="4313160"/>
                <a:tab algn="l" pos="4705200"/>
                <a:tab algn="l" pos="5097600"/>
                <a:tab algn="l" pos="5489640"/>
                <a:tab algn="l" pos="5881680"/>
                <a:tab algn="l" pos="6273720"/>
                <a:tab algn="l" pos="6665760"/>
                <a:tab algn="l" pos="7058160"/>
                <a:tab algn="l" pos="7450200"/>
                <a:tab algn="l" pos="7842240"/>
              </a:tabLst>
            </a:pPr>
            <a:fld id="{9CB1616B-30C5-423D-B0BF-819C0174122F}" type="slidenum">
              <a:rPr b="0" lang="en-I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143000" y="695160"/>
            <a:ext cx="4567320" cy="342612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392040"/>
                <a:tab algn="l" pos="784080"/>
                <a:tab algn="l" pos="1176480"/>
                <a:tab algn="l" pos="1568520"/>
                <a:tab algn="l" pos="1960560"/>
                <a:tab algn="l" pos="2352600"/>
                <a:tab algn="l" pos="2744640"/>
                <a:tab algn="l" pos="3137040"/>
                <a:tab algn="l" pos="3529080"/>
                <a:tab algn="l" pos="3921120"/>
                <a:tab algn="l" pos="4313160"/>
                <a:tab algn="l" pos="4705200"/>
                <a:tab algn="l" pos="5097600"/>
                <a:tab algn="l" pos="5489640"/>
                <a:tab algn="l" pos="5881680"/>
                <a:tab algn="l" pos="6273720"/>
                <a:tab algn="l" pos="6665760"/>
                <a:tab algn="l" pos="7058160"/>
                <a:tab algn="l" pos="7450200"/>
                <a:tab algn="l" pos="7842240"/>
              </a:tabLst>
            </a:pPr>
            <a:fld id="{099448C1-0850-46E3-ADE1-B769B7BA4F9B}" type="slidenum">
              <a:rPr b="0" lang="en-I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3000" y="695160"/>
            <a:ext cx="4567320" cy="342612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392040"/>
                <a:tab algn="l" pos="784080"/>
                <a:tab algn="l" pos="1176480"/>
                <a:tab algn="l" pos="1568520"/>
                <a:tab algn="l" pos="1960560"/>
                <a:tab algn="l" pos="2352600"/>
                <a:tab algn="l" pos="2744640"/>
                <a:tab algn="l" pos="3137040"/>
                <a:tab algn="l" pos="3529080"/>
                <a:tab algn="l" pos="3921120"/>
                <a:tab algn="l" pos="4313160"/>
                <a:tab algn="l" pos="4705200"/>
                <a:tab algn="l" pos="5097600"/>
                <a:tab algn="l" pos="5489640"/>
                <a:tab algn="l" pos="5881680"/>
                <a:tab algn="l" pos="6273720"/>
                <a:tab algn="l" pos="6665760"/>
                <a:tab algn="l" pos="7058160"/>
                <a:tab algn="l" pos="7450200"/>
                <a:tab algn="l" pos="7842240"/>
              </a:tabLst>
            </a:pPr>
            <a:fld id="{94FF6B6E-C99A-46E7-9FDB-FA789DCF0C52}" type="slidenum">
              <a:rPr b="0" lang="en-I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0BF6B-182F-4960-867F-506B4C1A97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DD5A7-14E1-43D3-9F00-AB0FE1A6BB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ECC61-1567-47D8-B95E-89C3F07CAB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59CDC-0068-4660-B07A-E01CE57F54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0D6FF-5859-438D-8307-40A87DACAA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E059E9-9AF6-45C6-AA8D-D866806D72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988CB-8209-4EA0-AFA0-4D4A204D60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DD760-4656-4E67-B89C-F61C707110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62EE6-D3E0-4424-BEC3-6490B598D4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8FCEC-EF25-41A5-8F90-4ACCB23ACC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BD641-EA2E-4D2E-9FC9-BDF3A298B0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30828-A02A-47EC-9310-AD98A460CF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24C4F6-C9B1-446B-BCDD-73486A2182A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6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61920" y="968400"/>
            <a:ext cx="9072720" cy="398160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"/>
          <p:cNvSpPr/>
          <p:nvPr/>
        </p:nvSpPr>
        <p:spPr>
          <a:xfrm>
            <a:off x="380880" y="4572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3"/>
          <p:cNvGrpSpPr/>
          <p:nvPr/>
        </p:nvGrpSpPr>
        <p:grpSpPr>
          <a:xfrm>
            <a:off x="380880" y="214200"/>
            <a:ext cx="7000920" cy="5565960"/>
            <a:chOff x="380880" y="214200"/>
            <a:chExt cx="7000920" cy="5565960"/>
          </a:xfrm>
        </p:grpSpPr>
        <p:pic>
          <p:nvPicPr>
            <p:cNvPr id="51" name="Picture 2" descr=""/>
            <p:cNvPicPr/>
            <p:nvPr/>
          </p:nvPicPr>
          <p:blipFill>
            <a:blip r:embed="rId1"/>
            <a:stretch/>
          </p:blipFill>
          <p:spPr>
            <a:xfrm>
              <a:off x="1530720" y="214200"/>
              <a:ext cx="5851080" cy="556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Rectangle 3"/>
            <p:cNvSpPr/>
            <p:nvPr/>
          </p:nvSpPr>
          <p:spPr>
            <a:xfrm>
              <a:off x="380880" y="456120"/>
              <a:ext cx="2514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N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pplementary Figure  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"/>
          <p:cNvPicPr/>
          <p:nvPr/>
        </p:nvPicPr>
        <p:blipFill>
          <a:blip r:embed="rId1"/>
          <a:srcRect l="4866" t="12345" r="4866" b="0"/>
          <a:stretch/>
        </p:blipFill>
        <p:spPr>
          <a:xfrm>
            <a:off x="0" y="525600"/>
            <a:ext cx="9144000" cy="29509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" descr=""/>
          <p:cNvPicPr/>
          <p:nvPr/>
        </p:nvPicPr>
        <p:blipFill>
          <a:blip r:embed="rId2"/>
          <a:srcRect l="2384" t="11462" r="2922" b="0"/>
          <a:stretch/>
        </p:blipFill>
        <p:spPr>
          <a:xfrm>
            <a:off x="0" y="3476520"/>
            <a:ext cx="9144000" cy="310536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6"/>
          <p:cNvSpPr/>
          <p:nvPr/>
        </p:nvSpPr>
        <p:spPr>
          <a:xfrm>
            <a:off x="9000" y="0"/>
            <a:ext cx="2540880" cy="35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3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6"/>
          <p:cNvSpPr/>
          <p:nvPr/>
        </p:nvSpPr>
        <p:spPr>
          <a:xfrm>
            <a:off x="9360" y="3124080"/>
            <a:ext cx="2552760" cy="35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3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3" descr="C:\Users\RKS\Desktop\Picture1.png"/>
          <p:cNvPicPr/>
          <p:nvPr/>
        </p:nvPicPr>
        <p:blipFill>
          <a:blip r:embed="rId1"/>
          <a:srcRect l="1464" t="2626" r="3132" b="0"/>
          <a:stretch/>
        </p:blipFill>
        <p:spPr>
          <a:xfrm>
            <a:off x="1219320" y="1143000"/>
            <a:ext cx="6705360" cy="4925880"/>
          </a:xfrm>
          <a:prstGeom prst="rect">
            <a:avLst/>
          </a:prstGeom>
          <a:ln w="0">
            <a:noFill/>
          </a:ln>
        </p:spPr>
      </p:pic>
      <p:sp>
        <p:nvSpPr>
          <p:cNvPr id="58" name="TextBox 4"/>
          <p:cNvSpPr/>
          <p:nvPr/>
        </p:nvSpPr>
        <p:spPr>
          <a:xfrm>
            <a:off x="76320" y="30492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2" descr=""/>
          <p:cNvPicPr/>
          <p:nvPr/>
        </p:nvPicPr>
        <p:blipFill>
          <a:blip r:embed="rId1"/>
          <a:srcRect l="1203" t="12380" r="4432" b="924"/>
          <a:stretch/>
        </p:blipFill>
        <p:spPr>
          <a:xfrm>
            <a:off x="1143000" y="1066680"/>
            <a:ext cx="7315200" cy="5029200"/>
          </a:xfrm>
          <a:prstGeom prst="rect">
            <a:avLst/>
          </a:prstGeom>
          <a:ln w="0">
            <a:noFill/>
          </a:ln>
        </p:spPr>
      </p:pic>
      <p:sp>
        <p:nvSpPr>
          <p:cNvPr id="60" name="TextBox 2"/>
          <p:cNvSpPr/>
          <p:nvPr/>
        </p:nvSpPr>
        <p:spPr>
          <a:xfrm>
            <a:off x="-762120" y="304920"/>
            <a:ext cx="388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7"/>
          <p:cNvGrpSpPr/>
          <p:nvPr/>
        </p:nvGrpSpPr>
        <p:grpSpPr>
          <a:xfrm>
            <a:off x="79200" y="525600"/>
            <a:ext cx="3524040" cy="6332400"/>
            <a:chOff x="79200" y="525600"/>
            <a:chExt cx="3524040" cy="6332400"/>
          </a:xfrm>
        </p:grpSpPr>
        <p:pic>
          <p:nvPicPr>
            <p:cNvPr id="62" name="Picture 2" descr=""/>
            <p:cNvPicPr/>
            <p:nvPr/>
          </p:nvPicPr>
          <p:blipFill>
            <a:blip r:embed="rId1"/>
            <a:srcRect l="0" t="9113" r="9682" b="7367"/>
            <a:stretch/>
          </p:blipFill>
          <p:spPr>
            <a:xfrm rot="5400000">
              <a:off x="-1219320" y="2035080"/>
              <a:ext cx="6332400" cy="3313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3" name="Group 6"/>
            <p:cNvGrpSpPr/>
            <p:nvPr/>
          </p:nvGrpSpPr>
          <p:grpSpPr>
            <a:xfrm>
              <a:off x="79200" y="738720"/>
              <a:ext cx="1409760" cy="621360"/>
              <a:chOff x="79200" y="738720"/>
              <a:chExt cx="1409760" cy="621360"/>
            </a:xfrm>
          </p:grpSpPr>
          <p:sp>
            <p:nvSpPr>
              <p:cNvPr id="64" name="Rectangle 2"/>
              <p:cNvSpPr/>
              <p:nvPr/>
            </p:nvSpPr>
            <p:spPr>
              <a:xfrm>
                <a:off x="79200" y="755280"/>
                <a:ext cx="70200" cy="12744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3"/>
              <p:cNvSpPr/>
              <p:nvPr/>
            </p:nvSpPr>
            <p:spPr>
              <a:xfrm>
                <a:off x="79200" y="1138320"/>
                <a:ext cx="70200" cy="127440"/>
              </a:xfrm>
              <a:prstGeom prst="rect">
                <a:avLst/>
              </a:prstGeom>
              <a:solidFill>
                <a:srgbClr val="0070c0"/>
              </a:solidFill>
              <a:ln w="9360">
                <a:solidFill>
                  <a:srgbClr val="0070c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Box 4"/>
              <p:cNvSpPr/>
              <p:nvPr/>
            </p:nvSpPr>
            <p:spPr>
              <a:xfrm>
                <a:off x="149400" y="738720"/>
                <a:ext cx="1339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ownregulated  roo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TextBox 5"/>
              <p:cNvSpPr/>
              <p:nvPr/>
            </p:nvSpPr>
            <p:spPr>
              <a:xfrm>
                <a:off x="149400" y="1144440"/>
                <a:ext cx="98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Upregulated  root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8" name="Group 13"/>
          <p:cNvGrpSpPr/>
          <p:nvPr/>
        </p:nvGrpSpPr>
        <p:grpSpPr>
          <a:xfrm>
            <a:off x="3603600" y="623880"/>
            <a:ext cx="5540400" cy="5846760"/>
            <a:chOff x="3603600" y="623880"/>
            <a:chExt cx="5540400" cy="5846760"/>
          </a:xfrm>
        </p:grpSpPr>
        <p:pic>
          <p:nvPicPr>
            <p:cNvPr id="69" name="Picture 2" descr=""/>
            <p:cNvPicPr/>
            <p:nvPr/>
          </p:nvPicPr>
          <p:blipFill>
            <a:blip r:embed="rId2"/>
            <a:srcRect l="1325" t="12365" r="49296" b="0"/>
            <a:stretch/>
          </p:blipFill>
          <p:spPr>
            <a:xfrm>
              <a:off x="3682800" y="623880"/>
              <a:ext cx="4977360" cy="321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10" descr=""/>
            <p:cNvPicPr/>
            <p:nvPr/>
          </p:nvPicPr>
          <p:blipFill>
            <a:blip r:embed="rId3"/>
            <a:srcRect l="50707" t="9210" r="0" b="10525"/>
            <a:stretch/>
          </p:blipFill>
          <p:spPr>
            <a:xfrm>
              <a:off x="3603600" y="3762000"/>
              <a:ext cx="5540400" cy="2708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1" name="Rectangle 11"/>
          <p:cNvSpPr/>
          <p:nvPr/>
        </p:nvSpPr>
        <p:spPr>
          <a:xfrm>
            <a:off x="62640" y="-27000"/>
            <a:ext cx="2438640" cy="35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1"/>
          <p:cNvSpPr/>
          <p:nvPr/>
        </p:nvSpPr>
        <p:spPr>
          <a:xfrm>
            <a:off x="78120" y="380880"/>
            <a:ext cx="445320" cy="35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1"/>
          <p:cNvSpPr/>
          <p:nvPr/>
        </p:nvSpPr>
        <p:spPr>
          <a:xfrm>
            <a:off x="3819600" y="380880"/>
            <a:ext cx="445320" cy="35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6T07:17:20Z</dcterms:created>
  <dc:creator>MOKAR</dc:creator>
  <dc:description/>
  <dc:language>en-US</dc:language>
  <cp:lastModifiedBy>rk.shukla</cp:lastModifiedBy>
  <dcterms:modified xsi:type="dcterms:W3CDTF">2014-08-10T19:42:55Z</dcterms:modified>
  <cp:revision>6</cp:revision>
  <dc:subject/>
  <dc:title>Slide 1</dc:title>
</cp:coreProperties>
</file>